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1200" y="-25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7414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46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2750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2933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4109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2848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6026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0630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26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0854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9827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B28B2-9286-4520-BFE3-86A4BEA16669}" type="datetimeFigureOut">
              <a:rPr lang="it-IT" smtClean="0"/>
              <a:t>09/09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E0F73-71D4-4800-B5BF-FE93F115750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4520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1187624" y="5886404"/>
            <a:ext cx="7416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supervised clustering analysis of the Euclidean distances of gene expression data (30,864 genes) in the four diagnosis-remission paired samples (couples Ai</a:t>
            </a:r>
            <a:r>
              <a:rPr lang="en-US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i</a:t>
            </a:r>
            <a:r>
              <a:rPr lang="en-US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1,2,3,4). </a:t>
            </a:r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3808" y="1556792"/>
            <a:ext cx="3060457" cy="32067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3160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 Russo</dc:creator>
  <cp:lastModifiedBy>MDPI</cp:lastModifiedBy>
  <cp:revision>8</cp:revision>
  <dcterms:created xsi:type="dcterms:W3CDTF">2018-07-06T10:29:02Z</dcterms:created>
  <dcterms:modified xsi:type="dcterms:W3CDTF">2021-09-09T06:09:12Z</dcterms:modified>
</cp:coreProperties>
</file>